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E:\1. 课题\2. 文章相关1\6.机制\U0126-K5\ranbp3  p-erk--kr (shang)k5(xia)-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59632" y="0"/>
            <a:ext cx="8352928" cy="6096000"/>
          </a:xfrm>
          <a:prstGeom prst="rect">
            <a:avLst/>
          </a:prstGeom>
          <a:noFill/>
        </p:spPr>
      </p:pic>
      <p:sp>
        <p:nvSpPr>
          <p:cNvPr id="9" name="TextBox 8"/>
          <p:cNvSpPr txBox="1"/>
          <p:nvPr/>
        </p:nvSpPr>
        <p:spPr>
          <a:xfrm>
            <a:off x="5219512" y="404664"/>
            <a:ext cx="801552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</a:t>
            </a:r>
            <a:endParaRPr lang="zh-CN" altLang="en-US" sz="2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6074144" y="404664"/>
            <a:ext cx="160310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/G01</a:t>
            </a:r>
            <a:endParaRPr lang="zh-CN" altLang="en-US" sz="2000" b="1" dirty="0"/>
          </a:p>
        </p:txBody>
      </p:sp>
      <p:cxnSp>
        <p:nvCxnSpPr>
          <p:cNvPr id="12" name="直接连接符 11"/>
          <p:cNvCxnSpPr/>
          <p:nvPr/>
        </p:nvCxnSpPr>
        <p:spPr>
          <a:xfrm>
            <a:off x="5228976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6237088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220864" y="836712"/>
            <a:ext cx="87356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U0126</a:t>
            </a:r>
            <a:endParaRPr lang="zh-CN" altLang="en-US" sz="20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5156968" y="836712"/>
            <a:ext cx="2232248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-      +        -      +</a:t>
            </a:r>
            <a:endParaRPr lang="zh-CN" altLang="en-US" sz="2000" b="1" dirty="0"/>
          </a:p>
        </p:txBody>
      </p:sp>
      <p:sp>
        <p:nvSpPr>
          <p:cNvPr id="17" name="标题 1"/>
          <p:cNvSpPr txBox="1">
            <a:spLocks/>
          </p:cNvSpPr>
          <p:nvPr/>
        </p:nvSpPr>
        <p:spPr>
          <a:xfrm>
            <a:off x="2411760" y="2492896"/>
            <a:ext cx="2160240" cy="36004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45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RanBP3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5220072" y="260648"/>
            <a:ext cx="2232248" cy="2376264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1. 课题\2. 文章相关1\6.机制\U0126-K5\-p-ranbp3 -k5 (shang)kr(xia)-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28328" y="1052736"/>
            <a:ext cx="7032104" cy="5274078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5219512" y="404664"/>
            <a:ext cx="801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</a:t>
            </a:r>
            <a:endParaRPr lang="zh-CN" altLang="en-US" sz="2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074144" y="404664"/>
            <a:ext cx="1603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/G01</a:t>
            </a:r>
            <a:endParaRPr lang="zh-CN" altLang="en-US" sz="2000" b="1" dirty="0"/>
          </a:p>
        </p:txBody>
      </p:sp>
      <p:cxnSp>
        <p:nvCxnSpPr>
          <p:cNvPr id="10" name="直接连接符 9"/>
          <p:cNvCxnSpPr/>
          <p:nvPr/>
        </p:nvCxnSpPr>
        <p:spPr>
          <a:xfrm>
            <a:off x="5228976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6237088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220864" y="836712"/>
            <a:ext cx="873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U0126</a:t>
            </a:r>
            <a:endParaRPr lang="zh-CN" altLang="en-US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156968" y="836712"/>
            <a:ext cx="22322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-      +        -      +</a:t>
            </a:r>
            <a:endParaRPr lang="zh-CN" altLang="en-US" sz="2000" b="1" dirty="0"/>
          </a:p>
        </p:txBody>
      </p:sp>
      <p:sp>
        <p:nvSpPr>
          <p:cNvPr id="17" name="标题 1"/>
          <p:cNvSpPr txBox="1">
            <a:spLocks/>
          </p:cNvSpPr>
          <p:nvPr/>
        </p:nvSpPr>
        <p:spPr>
          <a:xfrm>
            <a:off x="476448" y="2564904"/>
            <a:ext cx="2160240" cy="36004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45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anBP3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5076056" y="1628800"/>
            <a:ext cx="2232248" cy="1584176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1. 课题\2. 文章相关1\6.机制\U0126-K5\p-erk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24000" y="1143000"/>
            <a:ext cx="7152456" cy="5364342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5219512" y="404664"/>
            <a:ext cx="801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</a:t>
            </a:r>
            <a:endParaRPr lang="zh-CN" altLang="en-US" sz="2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074144" y="404664"/>
            <a:ext cx="1603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/G01</a:t>
            </a:r>
            <a:endParaRPr lang="zh-CN" altLang="en-US" sz="2000" b="1" dirty="0"/>
          </a:p>
        </p:txBody>
      </p:sp>
      <p:cxnSp>
        <p:nvCxnSpPr>
          <p:cNvPr id="10" name="直接连接符 9"/>
          <p:cNvCxnSpPr/>
          <p:nvPr/>
        </p:nvCxnSpPr>
        <p:spPr>
          <a:xfrm>
            <a:off x="5228976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6237088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220864" y="836712"/>
            <a:ext cx="873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U0126</a:t>
            </a:r>
            <a:endParaRPr lang="zh-CN" altLang="en-US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156968" y="836712"/>
            <a:ext cx="22322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-      +        -      +</a:t>
            </a:r>
            <a:endParaRPr lang="zh-CN" altLang="en-US" sz="2000" b="1" dirty="0"/>
          </a:p>
        </p:txBody>
      </p:sp>
      <p:sp>
        <p:nvSpPr>
          <p:cNvPr id="18" name="标题 1"/>
          <p:cNvSpPr txBox="1">
            <a:spLocks/>
          </p:cNvSpPr>
          <p:nvPr/>
        </p:nvSpPr>
        <p:spPr>
          <a:xfrm>
            <a:off x="476448" y="3284984"/>
            <a:ext cx="2160240" cy="36004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45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ERK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5076056" y="1628800"/>
            <a:ext cx="2232248" cy="4752528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1. 课题\2. 文章相关1\6.机制\U0126-K5\ERK 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8" y="1143000"/>
            <a:ext cx="7296472" cy="5472354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5219512" y="404664"/>
            <a:ext cx="801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</a:t>
            </a:r>
            <a:endParaRPr lang="zh-CN" altLang="en-US" sz="2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074144" y="404664"/>
            <a:ext cx="1603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/G01</a:t>
            </a:r>
            <a:endParaRPr lang="zh-CN" altLang="en-US" sz="2000" b="1" dirty="0"/>
          </a:p>
        </p:txBody>
      </p:sp>
      <p:cxnSp>
        <p:nvCxnSpPr>
          <p:cNvPr id="10" name="直接连接符 9"/>
          <p:cNvCxnSpPr/>
          <p:nvPr/>
        </p:nvCxnSpPr>
        <p:spPr>
          <a:xfrm>
            <a:off x="5228976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6237088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220864" y="836712"/>
            <a:ext cx="873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U0126</a:t>
            </a:r>
            <a:endParaRPr lang="zh-CN" altLang="en-US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156968" y="836712"/>
            <a:ext cx="22322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-      +        -      +</a:t>
            </a:r>
            <a:endParaRPr lang="zh-CN" altLang="en-US" sz="2000" b="1" dirty="0"/>
          </a:p>
        </p:txBody>
      </p:sp>
      <p:sp>
        <p:nvSpPr>
          <p:cNvPr id="14" name="标题 1"/>
          <p:cNvSpPr txBox="1">
            <a:spLocks/>
          </p:cNvSpPr>
          <p:nvPr/>
        </p:nvSpPr>
        <p:spPr>
          <a:xfrm>
            <a:off x="899592" y="3284984"/>
            <a:ext cx="2160240" cy="36004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45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RK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5076056" y="1628800"/>
            <a:ext cx="2232248" cy="4752528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1. 课题\2. 文章相关1\6.机制\U0126-K5\p-bad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87624" y="-1395536"/>
            <a:ext cx="7956376" cy="5886654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5219512" y="404664"/>
            <a:ext cx="801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</a:t>
            </a:r>
            <a:endParaRPr lang="zh-CN" altLang="en-US" sz="2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074144" y="404664"/>
            <a:ext cx="1603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/G01</a:t>
            </a:r>
            <a:endParaRPr lang="zh-CN" altLang="en-US" sz="2000" b="1" dirty="0"/>
          </a:p>
        </p:txBody>
      </p:sp>
      <p:cxnSp>
        <p:nvCxnSpPr>
          <p:cNvPr id="10" name="直接连接符 9"/>
          <p:cNvCxnSpPr/>
          <p:nvPr/>
        </p:nvCxnSpPr>
        <p:spPr>
          <a:xfrm>
            <a:off x="5228976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6237088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220864" y="836712"/>
            <a:ext cx="873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U0126</a:t>
            </a:r>
            <a:endParaRPr lang="zh-CN" altLang="en-US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156968" y="836712"/>
            <a:ext cx="22322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-      +        -      +</a:t>
            </a:r>
            <a:endParaRPr lang="zh-CN" altLang="en-US" sz="2000" b="1" dirty="0"/>
          </a:p>
        </p:txBody>
      </p:sp>
      <p:sp>
        <p:nvSpPr>
          <p:cNvPr id="19" name="标题 1"/>
          <p:cNvSpPr txBox="1">
            <a:spLocks/>
          </p:cNvSpPr>
          <p:nvPr/>
        </p:nvSpPr>
        <p:spPr>
          <a:xfrm>
            <a:off x="1043608" y="2060848"/>
            <a:ext cx="2160240" cy="36004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45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BAD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5148064" y="404664"/>
            <a:ext cx="2232248" cy="2016224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1. 课题\2. 文章相关1\6.机制\U0126-K5\actin 2500-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9552" y="-1899592"/>
            <a:ext cx="8388424" cy="6291318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5219512" y="404664"/>
            <a:ext cx="801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</a:t>
            </a:r>
            <a:endParaRPr lang="zh-CN" altLang="en-US" sz="2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074144" y="404664"/>
            <a:ext cx="1603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K562/G01</a:t>
            </a:r>
            <a:endParaRPr lang="zh-CN" altLang="en-US" sz="2000" b="1" dirty="0"/>
          </a:p>
        </p:txBody>
      </p:sp>
      <p:cxnSp>
        <p:nvCxnSpPr>
          <p:cNvPr id="10" name="直接连接符 9"/>
          <p:cNvCxnSpPr/>
          <p:nvPr/>
        </p:nvCxnSpPr>
        <p:spPr>
          <a:xfrm>
            <a:off x="5228976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6237088" y="764704"/>
            <a:ext cx="72008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220864" y="836712"/>
            <a:ext cx="873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U0126</a:t>
            </a:r>
            <a:endParaRPr lang="zh-CN" altLang="en-US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156968" y="836712"/>
            <a:ext cx="22322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-      +        -      +</a:t>
            </a:r>
            <a:endParaRPr lang="zh-CN" altLang="en-US" sz="2000" b="1" dirty="0"/>
          </a:p>
        </p:txBody>
      </p:sp>
      <p:sp>
        <p:nvSpPr>
          <p:cNvPr id="20" name="矩形 19"/>
          <p:cNvSpPr/>
          <p:nvPr/>
        </p:nvSpPr>
        <p:spPr>
          <a:xfrm>
            <a:off x="5076056" y="260648"/>
            <a:ext cx="2232248" cy="3744416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标题 1"/>
          <p:cNvSpPr txBox="1">
            <a:spLocks/>
          </p:cNvSpPr>
          <p:nvPr/>
        </p:nvSpPr>
        <p:spPr>
          <a:xfrm>
            <a:off x="1043608" y="2060848"/>
            <a:ext cx="2160240" cy="36004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45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CTIN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8</Words>
  <Application>Microsoft Office PowerPoint</Application>
  <PresentationFormat>全屏显示(4:3)</PresentationFormat>
  <Paragraphs>30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QIAN</cp:lastModifiedBy>
  <cp:revision>4</cp:revision>
  <dcterms:created xsi:type="dcterms:W3CDTF">2021-05-07T13:24:30Z</dcterms:created>
  <dcterms:modified xsi:type="dcterms:W3CDTF">2021-05-10T15:52:57Z</dcterms:modified>
</cp:coreProperties>
</file>